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DB5604-1D49-47D9-B962-31C91B45F4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A09C78A6-BCFB-4EDE-857C-AD3510C300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39B8A6D-FA33-4E46-9CA8-EC67EC7AE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E151274-3C17-4654-B2B0-DB06ED27F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A086DEB-FF57-4335-AFB3-D91BFFBAE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2508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75FF53B-F929-4BF4-824E-E18406CA1E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B3A6607-77E2-43BD-AA7D-01B7EA0892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AD30A88-9B7B-40AE-B9AC-45F33CA73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8A4AF41-FD62-452F-B161-1CC5BB10B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C58D02D-0ADF-4035-BE90-4255B6B92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8318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7BD0475-AABB-4099-A264-E65177B5DB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A4B7179-7CD3-4825-AA9D-8FDCCE1F21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CB8F63C-9338-4556-9AA9-7AD2CB02A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CC77F55-D8E5-4D22-B780-CAE0C5C2E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9F1E615-4C2F-40C6-9FAD-F0C25A5F4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0182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81DCC92-B450-484C-A0DB-2074FB1FC1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41F4DDB-8FEA-452C-A041-C923C6FA1C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35CF2BD-C465-49F2-A9E8-7A02D7EE06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04C1180-EAAC-4988-822B-BB8C66142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C761433-199F-4B71-84B9-4F239350E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5736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7F3264-8822-4169-AE51-796B7B6061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AEBE7B5-73E5-408E-9C5F-F7E6C066AC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585DA5-47D7-408B-91FA-F0156EF0B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81258E4-DA37-4877-97E1-3574816ED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BD1143E-6775-4E88-8254-3AAAFE9D1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6114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816355-96DB-4482-91F1-F0401DA2A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9A561C1-DEB1-4C82-8AA4-09FB2B2121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BACF3D0-CA71-45EA-9F68-96307CED03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B0BEE0B-1806-4B42-9C66-D5D841C44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1C164AD-296B-4C29-8A99-696768391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C45E33E-44B2-4BC1-9F94-109D186A2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9715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86D389A-8CB6-40D8-A2ED-A0EBAFBD5D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253676E-D32A-4C79-A245-D51769B358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FF46C1C-69A5-4C8C-96CC-3200B0CF7E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0278D22A-DC2D-4414-B67B-2B17B01CCB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8EC704B-FF95-4BF2-AE48-5589279555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E9A3DAA-D76C-4D59-BE74-63FFE9B52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85AE02D-1278-4D40-9484-7579EEF3B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D69BEAD-5EBD-426F-AE3D-3B12D3AFA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0813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29E1797-48C6-4631-B238-78CF01C61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BC0B288-0201-4797-B302-94BFD1D64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10D4FDB-3E18-4BC9-B996-BCD517CFA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85A3A4D-19A1-4512-9271-C579A8776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422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C2A924C-F0B7-4E1F-BC4A-68358B367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580AFBD-FCB6-47F0-A3FB-8122C0963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DC3FE46-E744-47D9-B194-13A4929C5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043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6474ABD-97EF-48BF-9220-F8F1D8E6A7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C8E4844-8134-4046-91E7-39094ACCE7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C4970D7-4AF1-410D-AFE5-7018FA750D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FEB72E6-77C8-4288-ABE6-46447F09C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67BA1DB-8322-4956-8067-301175C6B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BA73A68-CB8B-47B2-910C-FABF402B8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4210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6D9ACBB-F6EF-467D-935D-2E588CC28C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52D0ECC-E691-47C6-B78F-543D09773C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2B139EB-6FA8-440A-A291-2013E9E4DC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1998142-6F8B-47A2-9785-0C7376EE4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A1D6580-CA4B-4188-8141-721391BC6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36DDBF9-F04F-440C-85DB-AF990C576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3069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C8397DF-E8CF-4836-8844-7D6EC71926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7DA1DA8-840C-408B-9C2D-53A407F4C0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95D5F2D-6D91-42A0-9539-8953D0DEAF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A0B624-9B73-4A7F-A9CB-C4529FE399E6}" type="datetimeFigureOut">
              <a:rPr lang="fr-FR" smtClean="0"/>
              <a:t>15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0C1E9A9-4F67-443B-BF3A-C688932053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8416A07-40FA-454F-953B-DCDD9CF9FD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FC018B-FEA6-4DCC-92BC-5B749F3A3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7713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6">
            <a:extLst>
              <a:ext uri="{FF2B5EF4-FFF2-40B4-BE49-F238E27FC236}">
                <a16:creationId xmlns:a16="http://schemas.microsoft.com/office/drawing/2014/main" id="{4A66E5AE-316B-4CD1-8FB2-3FCEFC2786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7694565"/>
              </p:ext>
            </p:extLst>
          </p:nvPr>
        </p:nvGraphicFramePr>
        <p:xfrm>
          <a:off x="2032000" y="507861"/>
          <a:ext cx="8128000" cy="5694957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4064000">
                  <a:extLst>
                    <a:ext uri="{9D8B030D-6E8A-4147-A177-3AD203B41FA5}">
                      <a16:colId xmlns:a16="http://schemas.microsoft.com/office/drawing/2014/main" val="3197178949"/>
                    </a:ext>
                  </a:extLst>
                </a:gridCol>
                <a:gridCol w="4064000">
                  <a:extLst>
                    <a:ext uri="{9D8B030D-6E8A-4147-A177-3AD203B41FA5}">
                      <a16:colId xmlns:a16="http://schemas.microsoft.com/office/drawing/2014/main" val="1305357666"/>
                    </a:ext>
                  </a:extLst>
                </a:gridCol>
              </a:tblGrid>
              <a:tr h="355877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Vari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n=16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850448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/>
                        <a:t>Women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136 (84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56534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Age, </a:t>
                      </a:r>
                      <a:r>
                        <a:rPr lang="fr-FR" sz="1400" b="1" dirty="0" err="1"/>
                        <a:t>mean</a:t>
                      </a:r>
                      <a:r>
                        <a:rPr lang="fr-FR" sz="1400" b="1" dirty="0"/>
                        <a:t> ± S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60 ± 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58403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Limited </a:t>
                      </a:r>
                      <a:r>
                        <a:rPr lang="fr-FR" sz="1400" b="1" dirty="0" err="1"/>
                        <a:t>cutaneous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SSc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93 (58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761057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Diffuse </a:t>
                      </a:r>
                      <a:r>
                        <a:rPr lang="fr-FR" sz="1400" b="1" dirty="0" err="1"/>
                        <a:t>cutaneous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SSc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68 (42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31618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/>
                        <a:t>Disease</a:t>
                      </a:r>
                      <a:r>
                        <a:rPr lang="fr-FR" sz="1400" b="1" dirty="0"/>
                        <a:t> duration, </a:t>
                      </a:r>
                      <a:r>
                        <a:rPr lang="fr-FR" sz="1400" b="1" dirty="0" err="1"/>
                        <a:t>mean</a:t>
                      </a:r>
                      <a:r>
                        <a:rPr lang="fr-FR" sz="1400" b="1" dirty="0"/>
                        <a:t> ± SD (</a:t>
                      </a:r>
                      <a:r>
                        <a:rPr lang="fr-FR" sz="1400" b="1" dirty="0" err="1"/>
                        <a:t>years</a:t>
                      </a:r>
                      <a:r>
                        <a:rPr lang="fr-FR" sz="1400" b="1" dirty="0"/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11 ± 9 [&lt;1-45]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49425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/>
                        <a:t>Modified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Rodnan</a:t>
                      </a:r>
                      <a:r>
                        <a:rPr lang="fr-FR" sz="1400" b="1" dirty="0"/>
                        <a:t> skin score ± S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6,6 ± 6,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65260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CRP&gt;5mg/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39 (24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81159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/>
                        <a:t>Interstitial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lung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disease</a:t>
                      </a:r>
                      <a:r>
                        <a:rPr lang="fr-FR" sz="1400" b="1" dirty="0"/>
                        <a:t> (ILD) on </a:t>
                      </a:r>
                      <a:r>
                        <a:rPr lang="fr-FR" sz="1400" b="1" dirty="0" err="1"/>
                        <a:t>computed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tomography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51 (32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11030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Restrictive syndrome (</a:t>
                      </a:r>
                      <a:r>
                        <a:rPr lang="fr-FR" sz="1400" b="1" dirty="0" err="1"/>
                        <a:t>defined</a:t>
                      </a:r>
                      <a:r>
                        <a:rPr lang="fr-FR" sz="1400" b="1" dirty="0"/>
                        <a:t> by FVC&lt;7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26 (16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4615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PAH </a:t>
                      </a:r>
                      <a:r>
                        <a:rPr lang="fr-FR" sz="1400" b="1" dirty="0" err="1"/>
                        <a:t>defined</a:t>
                      </a:r>
                      <a:r>
                        <a:rPr lang="fr-FR" sz="1400" b="1" dirty="0"/>
                        <a:t> on right </a:t>
                      </a:r>
                      <a:r>
                        <a:rPr lang="fr-FR" sz="1400" b="1" dirty="0" err="1"/>
                        <a:t>heart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catheterization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9 (6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9636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Positive anti-</a:t>
                      </a:r>
                      <a:r>
                        <a:rPr lang="fr-FR" sz="1400" b="1" dirty="0" err="1"/>
                        <a:t>nuclear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antibodies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153 (95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11671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Positive anti-</a:t>
                      </a:r>
                      <a:r>
                        <a:rPr lang="fr-FR" sz="1400" b="1" dirty="0" err="1"/>
                        <a:t>centromere</a:t>
                      </a:r>
                      <a:r>
                        <a:rPr lang="fr-FR" sz="1400" b="1" dirty="0"/>
                        <a:t> </a:t>
                      </a:r>
                      <a:r>
                        <a:rPr lang="fr-FR" sz="1400" b="1" dirty="0" err="1"/>
                        <a:t>antibodies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54 (34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29184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Positive anti-</a:t>
                      </a:r>
                      <a:r>
                        <a:rPr lang="fr-FR" sz="1400" b="1" dirty="0" err="1"/>
                        <a:t>topoisomerase</a:t>
                      </a:r>
                      <a:r>
                        <a:rPr lang="fr-FR" sz="1400" b="1" dirty="0"/>
                        <a:t> I </a:t>
                      </a:r>
                      <a:r>
                        <a:rPr lang="fr-FR" sz="1400" b="1" dirty="0" err="1"/>
                        <a:t>antibodies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49 (30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63109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/>
                        <a:t>Positive anti-RNA </a:t>
                      </a:r>
                      <a:r>
                        <a:rPr lang="fr-FR" sz="1400" b="1" dirty="0" err="1"/>
                        <a:t>polymerase</a:t>
                      </a:r>
                      <a:r>
                        <a:rPr lang="fr-FR" sz="1400" b="1" dirty="0"/>
                        <a:t> III </a:t>
                      </a:r>
                      <a:r>
                        <a:rPr lang="fr-FR" sz="1400" b="1" dirty="0" err="1"/>
                        <a:t>antibodies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14 (9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1283858"/>
                  </a:ext>
                </a:extLst>
              </a:tr>
            </a:tbl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7E829AC6-CDC7-4865-8042-EEEEF2E47FAC}"/>
              </a:ext>
            </a:extLst>
          </p:cNvPr>
          <p:cNvSpPr txBox="1"/>
          <p:nvPr/>
        </p:nvSpPr>
        <p:spPr>
          <a:xfrm>
            <a:off x="106017" y="0"/>
            <a:ext cx="2875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Table 1</a:t>
            </a:r>
          </a:p>
        </p:txBody>
      </p:sp>
    </p:spTree>
    <p:extLst>
      <p:ext uri="{BB962C8B-B14F-4D97-AF65-F5344CB8AC3E}">
        <p14:creationId xmlns:p14="http://schemas.microsoft.com/office/powerpoint/2010/main" val="17433138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3</TotalTime>
  <Words>134</Words>
  <Application>Microsoft Office PowerPoint</Application>
  <PresentationFormat>Grand écran</PresentationFormat>
  <Paragraphs>3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indy Orvain</dc:creator>
  <cp:lastModifiedBy>Cindy Orvain</cp:lastModifiedBy>
  <cp:revision>4</cp:revision>
  <dcterms:created xsi:type="dcterms:W3CDTF">2021-11-27T11:31:57Z</dcterms:created>
  <dcterms:modified xsi:type="dcterms:W3CDTF">2021-12-15T19:23:15Z</dcterms:modified>
</cp:coreProperties>
</file>